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51090-1A10-4A95-8813-0B5A67AEAB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2A9CE-EF1C-4E3E-8A7C-6D04CCAF40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FCADC-B65E-4F00-8FB0-3F07823A7D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C620D-B81A-40ED-83EA-BDE1D01AEF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342067-549F-4EF6-A402-E53A922D25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5F4641-8055-42BD-BC79-69B71AE8B5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E15A4-18CC-484B-A12C-31A32DB7E0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6A65F4-FEF3-467B-AC27-D8C3A0C2C8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36C64-DE15-4859-A73C-9018BFC5A3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C97F9-7440-41E9-812E-6D6B88DD88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55937-AFDA-44CB-ACB2-81C2AEF031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03FB6B-17BE-49D2-A717-A004D0D57E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BF009F-7020-47B9-9F92-EAFD996ECB8C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2A4858-4641-4330-B642-E1B177E4FA0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25" descr=""/>
          <p:cNvPicPr/>
          <p:nvPr/>
        </p:nvPicPr>
        <p:blipFill>
          <a:blip r:embed="rId1"/>
          <a:stretch/>
        </p:blipFill>
        <p:spPr>
          <a:xfrm>
            <a:off x="906480" y="1901880"/>
            <a:ext cx="1079640" cy="17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図 27" descr=""/>
          <p:cNvPicPr/>
          <p:nvPr/>
        </p:nvPicPr>
        <p:blipFill>
          <a:blip r:embed="rId2"/>
          <a:stretch/>
        </p:blipFill>
        <p:spPr>
          <a:xfrm>
            <a:off x="906480" y="3070080"/>
            <a:ext cx="1079640" cy="1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図 28" descr=""/>
          <p:cNvPicPr/>
          <p:nvPr/>
        </p:nvPicPr>
        <p:blipFill>
          <a:blip r:embed="rId3">
            <a:lum bright="10000"/>
          </a:blip>
          <a:stretch/>
        </p:blipFill>
        <p:spPr>
          <a:xfrm>
            <a:off x="906480" y="2138400"/>
            <a:ext cx="1079640" cy="1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4" name="図 29" descr=""/>
          <p:cNvPicPr/>
          <p:nvPr/>
        </p:nvPicPr>
        <p:blipFill>
          <a:blip r:embed="rId4">
            <a:lum bright="12000"/>
          </a:blip>
          <a:stretch/>
        </p:blipFill>
        <p:spPr>
          <a:xfrm>
            <a:off x="906480" y="2368440"/>
            <a:ext cx="1079640" cy="1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5" name="図 30" descr=""/>
          <p:cNvPicPr/>
          <p:nvPr/>
        </p:nvPicPr>
        <p:blipFill>
          <a:blip r:embed="rId5"/>
          <a:stretch/>
        </p:blipFill>
        <p:spPr>
          <a:xfrm>
            <a:off x="906480" y="2602080"/>
            <a:ext cx="1079640" cy="17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6" name="TextBox 4"/>
          <p:cNvSpPr/>
          <p:nvPr/>
        </p:nvSpPr>
        <p:spPr>
          <a:xfrm>
            <a:off x="1917720" y="2781360"/>
            <a:ext cx="58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h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27"/>
          <p:cNvSpPr/>
          <p:nvPr/>
        </p:nvSpPr>
        <p:spPr>
          <a:xfrm>
            <a:off x="1927080" y="3002040"/>
            <a:ext cx="94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1922400" y="2308320"/>
            <a:ext cx="104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RF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1930320" y="2079720"/>
            <a:ext cx="142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2A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5"/>
          <p:cNvSpPr/>
          <p:nvPr/>
        </p:nvSpPr>
        <p:spPr>
          <a:xfrm>
            <a:off x="1917720" y="2544840"/>
            <a:ext cx="93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図 37" descr=""/>
          <p:cNvPicPr/>
          <p:nvPr/>
        </p:nvPicPr>
        <p:blipFill>
          <a:blip r:embed="rId6">
            <a:lum bright="12000"/>
          </a:blip>
          <a:stretch/>
        </p:blipFill>
        <p:spPr>
          <a:xfrm>
            <a:off x="906480" y="2840040"/>
            <a:ext cx="1079640" cy="17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2" name="TextBox 18"/>
          <p:cNvSpPr/>
          <p:nvPr/>
        </p:nvSpPr>
        <p:spPr>
          <a:xfrm>
            <a:off x="906480" y="1655640"/>
            <a:ext cx="40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9"/>
          <p:cNvSpPr/>
          <p:nvPr/>
        </p:nvSpPr>
        <p:spPr>
          <a:xfrm>
            <a:off x="1166760" y="1655640"/>
            <a:ext cx="40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0"/>
          <p:cNvSpPr/>
          <p:nvPr/>
        </p:nvSpPr>
        <p:spPr>
          <a:xfrm>
            <a:off x="1422360" y="1655640"/>
            <a:ext cx="40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1"/>
          <p:cNvSpPr/>
          <p:nvPr/>
        </p:nvSpPr>
        <p:spPr>
          <a:xfrm>
            <a:off x="1689120" y="1655640"/>
            <a:ext cx="40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直線コネクタ 16"/>
          <p:cNvSpPr/>
          <p:nvPr/>
        </p:nvSpPr>
        <p:spPr>
          <a:xfrm>
            <a:off x="1000080" y="1687680"/>
            <a:ext cx="360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直線コネクタ 17"/>
          <p:cNvSpPr/>
          <p:nvPr/>
        </p:nvSpPr>
        <p:spPr>
          <a:xfrm>
            <a:off x="1496880" y="1687680"/>
            <a:ext cx="360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919080" y="1436760"/>
            <a:ext cx="71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1432080" y="1436760"/>
            <a:ext cx="71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h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892080" y="1143000"/>
            <a:ext cx="116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hR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iRNA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63"/>
          <p:cNvSpPr/>
          <p:nvPr/>
        </p:nvSpPr>
        <p:spPr>
          <a:xfrm>
            <a:off x="333360" y="3513240"/>
            <a:ext cx="61722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11. Effects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h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siRNA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on r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Vpr-induced chromatin recruitment of ORF1.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HuH-7 cells transfected with pORF1-TAP with control (lanes 1, 2) or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h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siRNAs (lanes 3, 4). After 2 days cells were treated for 24 h with 5ng rVpr, and fractionated cellular extracts were subjected to WB analysis. Lanes 1 and 3, Buffer (B); lanes 2 and 4, rVpr at 5 ng/mL (V).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23"/>
          <p:cNvSpPr/>
          <p:nvPr/>
        </p:nvSpPr>
        <p:spPr>
          <a:xfrm>
            <a:off x="907920" y="32097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23"/>
          <p:cNvSpPr/>
          <p:nvPr/>
        </p:nvSpPr>
        <p:spPr>
          <a:xfrm>
            <a:off x="1168560" y="32097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23"/>
          <p:cNvSpPr/>
          <p:nvPr/>
        </p:nvSpPr>
        <p:spPr>
          <a:xfrm>
            <a:off x="1440000" y="32097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23"/>
          <p:cNvSpPr/>
          <p:nvPr/>
        </p:nvSpPr>
        <p:spPr>
          <a:xfrm>
            <a:off x="1724040" y="32050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3"/>
          <p:cNvSpPr/>
          <p:nvPr/>
        </p:nvSpPr>
        <p:spPr>
          <a:xfrm>
            <a:off x="176040" y="5731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0"/>
          <p:cNvSpPr/>
          <p:nvPr/>
        </p:nvSpPr>
        <p:spPr>
          <a:xfrm>
            <a:off x="1916280" y="1857240"/>
            <a:ext cx="104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RF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1"/>
          <p:cNvSpPr/>
          <p:nvPr/>
        </p:nvSpPr>
        <p:spPr>
          <a:xfrm>
            <a:off x="387360" y="1971720"/>
            <a:ext cx="46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h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11"/>
          <p:cNvSpPr/>
          <p:nvPr/>
        </p:nvSpPr>
        <p:spPr>
          <a:xfrm>
            <a:off x="406440" y="2406600"/>
            <a:ext cx="46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y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183"/>
          <p:cNvSpPr/>
          <p:nvPr/>
        </p:nvSpPr>
        <p:spPr>
          <a:xfrm>
            <a:off x="855720" y="1908000"/>
            <a:ext cx="0" cy="397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1"/>
          <p:cNvSpPr/>
          <p:nvPr/>
        </p:nvSpPr>
        <p:spPr>
          <a:xfrm>
            <a:off x="341280" y="286560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W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183"/>
          <p:cNvSpPr/>
          <p:nvPr/>
        </p:nvSpPr>
        <p:spPr>
          <a:xfrm>
            <a:off x="853920" y="2387520"/>
            <a:ext cx="0" cy="397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183"/>
          <p:cNvSpPr/>
          <p:nvPr/>
        </p:nvSpPr>
        <p:spPr>
          <a:xfrm>
            <a:off x="853920" y="2846520"/>
            <a:ext cx="0" cy="395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54:50Z</dcterms:modified>
  <cp:revision>1632</cp:revision>
  <dc:subject/>
  <dc:title>スライド 1</dc:title>
</cp:coreProperties>
</file>